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8" d="100"/>
          <a:sy n="98" d="100"/>
        </p:scale>
        <p:origin x="-384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FBF84-E587-492D-8A34-939426D5E8F2}" type="datetimeFigureOut">
              <a:rPr kumimoji="1" lang="ja-JP" altLang="en-US" smtClean="0"/>
              <a:t>2016/7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5D286-5F17-4B44-89A4-2A4600CD7B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86013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FBF84-E587-492D-8A34-939426D5E8F2}" type="datetimeFigureOut">
              <a:rPr kumimoji="1" lang="ja-JP" altLang="en-US" smtClean="0"/>
              <a:t>2016/7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5D286-5F17-4B44-89A4-2A4600CD7B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58023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FBF84-E587-492D-8A34-939426D5E8F2}" type="datetimeFigureOut">
              <a:rPr kumimoji="1" lang="ja-JP" altLang="en-US" smtClean="0"/>
              <a:t>2016/7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5D286-5F17-4B44-89A4-2A4600CD7B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7931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FBF84-E587-492D-8A34-939426D5E8F2}" type="datetimeFigureOut">
              <a:rPr kumimoji="1" lang="ja-JP" altLang="en-US" smtClean="0"/>
              <a:t>2016/7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5D286-5F17-4B44-89A4-2A4600CD7B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43331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FBF84-E587-492D-8A34-939426D5E8F2}" type="datetimeFigureOut">
              <a:rPr kumimoji="1" lang="ja-JP" altLang="en-US" smtClean="0"/>
              <a:t>2016/7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5D286-5F17-4B44-89A4-2A4600CD7B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11698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FBF84-E587-492D-8A34-939426D5E8F2}" type="datetimeFigureOut">
              <a:rPr kumimoji="1" lang="ja-JP" altLang="en-US" smtClean="0"/>
              <a:t>2016/7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5D286-5F17-4B44-89A4-2A4600CD7B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5944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FBF84-E587-492D-8A34-939426D5E8F2}" type="datetimeFigureOut">
              <a:rPr kumimoji="1" lang="ja-JP" altLang="en-US" smtClean="0"/>
              <a:t>2016/7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5D286-5F17-4B44-89A4-2A4600CD7B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53613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FBF84-E587-492D-8A34-939426D5E8F2}" type="datetimeFigureOut">
              <a:rPr kumimoji="1" lang="ja-JP" altLang="en-US" smtClean="0"/>
              <a:t>2016/7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5D286-5F17-4B44-89A4-2A4600CD7B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13781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FBF84-E587-492D-8A34-939426D5E8F2}" type="datetimeFigureOut">
              <a:rPr kumimoji="1" lang="ja-JP" altLang="en-US" smtClean="0"/>
              <a:t>2016/7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5D286-5F17-4B44-89A4-2A4600CD7B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9557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FBF84-E587-492D-8A34-939426D5E8F2}" type="datetimeFigureOut">
              <a:rPr kumimoji="1" lang="ja-JP" altLang="en-US" smtClean="0"/>
              <a:t>2016/7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5D286-5F17-4B44-89A4-2A4600CD7B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0478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CFBF84-E587-492D-8A34-939426D5E8F2}" type="datetimeFigureOut">
              <a:rPr kumimoji="1" lang="ja-JP" altLang="en-US" smtClean="0"/>
              <a:t>2016/7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5D286-5F17-4B44-89A4-2A4600CD7B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203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CFBF84-E587-492D-8A34-939426D5E8F2}" type="datetimeFigureOut">
              <a:rPr kumimoji="1" lang="ja-JP" altLang="en-US" smtClean="0"/>
              <a:t>2016/7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55D286-5F17-4B44-89A4-2A4600CD7B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76818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07504" y="116632"/>
            <a:ext cx="3528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Supplementary </a:t>
            </a:r>
            <a:r>
              <a:rPr kumimoji="1" lang="en-US" altLang="ja-JP" smtClean="0"/>
              <a:t>Figure </a:t>
            </a:r>
            <a:r>
              <a:rPr kumimoji="1" lang="en-US" altLang="ja-JP" smtClean="0"/>
              <a:t>1</a:t>
            </a:r>
            <a:endParaRPr kumimoji="1" lang="ja-JP" altLang="en-US" dirty="0"/>
          </a:p>
        </p:txBody>
      </p:sp>
      <p:pic>
        <p:nvPicPr>
          <p:cNvPr id="4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2738" y="762395"/>
            <a:ext cx="4176464" cy="44938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テキスト ボックス 4"/>
          <p:cNvSpPr txBox="1"/>
          <p:nvPr/>
        </p:nvSpPr>
        <p:spPr>
          <a:xfrm>
            <a:off x="6300192" y="5256261"/>
            <a:ext cx="23397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IPAQ score</a:t>
            </a:r>
            <a:endParaRPr kumimoji="1" lang="ja-JP" altLang="en-US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23528" y="764704"/>
            <a:ext cx="2160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The change of CAVI</a:t>
            </a:r>
            <a:endParaRPr kumimoji="1" lang="ja-JP" altLang="en-US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887924" y="577730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Diabetic</a:t>
            </a:r>
            <a:endParaRPr kumimoji="1" lang="ja-JP" altLang="en-US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4860032" y="1377969"/>
            <a:ext cx="14401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R = -0.24</a:t>
            </a:r>
          </a:p>
          <a:p>
            <a:r>
              <a:rPr lang="en-US" altLang="ja-JP" dirty="0" smtClean="0"/>
              <a:t>(p = 0.018)</a:t>
            </a:r>
            <a:endParaRPr kumimoji="1" lang="ja-JP" altLang="en-US" dirty="0"/>
          </a:p>
        </p:txBody>
      </p:sp>
      <p:sp>
        <p:nvSpPr>
          <p:cNvPr id="9" name="正方形/長方形 8"/>
          <p:cNvSpPr/>
          <p:nvPr/>
        </p:nvSpPr>
        <p:spPr>
          <a:xfrm>
            <a:off x="683568" y="5733256"/>
            <a:ext cx="784887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/>
              <a:t>The relationship between </a:t>
            </a:r>
            <a:r>
              <a:rPr lang="en-US" altLang="ja-JP" dirty="0" smtClean="0"/>
              <a:t>the change </a:t>
            </a:r>
            <a:r>
              <a:rPr lang="en-US" altLang="ja-JP" dirty="0"/>
              <a:t>of CAVI </a:t>
            </a:r>
            <a:r>
              <a:rPr lang="en-US" altLang="ja-JP" dirty="0" smtClean="0"/>
              <a:t>and IPAQ score in patients with diabetes. There was a significant negative correlation between these two.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8142814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44</Words>
  <Application>Microsoft Office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ea</dc:creator>
  <cp:lastModifiedBy>ea</cp:lastModifiedBy>
  <cp:revision>8</cp:revision>
  <dcterms:created xsi:type="dcterms:W3CDTF">2016-06-27T13:53:19Z</dcterms:created>
  <dcterms:modified xsi:type="dcterms:W3CDTF">2016-07-27T15:49:55Z</dcterms:modified>
</cp:coreProperties>
</file>